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193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&#23455;&#39443;\WB&#32080;&#26524;(&#25968;&#20516;&#21270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0217(GLUT1,LDHA,PGD)'!$R$6:$R$7</c:f>
                <c:numCache>
                  <c:formatCode>General</c:formatCode>
                  <c:ptCount val="2"/>
                  <c:pt idx="0">
                    <c:v>0.23786018576876844</c:v>
                  </c:pt>
                  <c:pt idx="1">
                    <c:v>0.18761799218766037</c:v>
                  </c:pt>
                </c:numCache>
              </c:numRef>
            </c:plus>
            <c:minus>
              <c:numRef>
                <c:f>'0217(GLUT1,LDHA,PGD)'!$R$6:$R$7</c:f>
                <c:numCache>
                  <c:formatCode>General</c:formatCode>
                  <c:ptCount val="2"/>
                  <c:pt idx="0">
                    <c:v>0.23786018576876844</c:v>
                  </c:pt>
                  <c:pt idx="1">
                    <c:v>0.18761799218766037</c:v>
                  </c:pt>
                </c:numCache>
              </c:numRef>
            </c:minus>
          </c:errBars>
          <c:cat>
            <c:strRef>
              <c:f>'0217(GLUT1,LDHA,PGD)'!$J$6:$J$7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'0217(GLUT1,LDHA,PGD)'!$Q$6:$Q$7</c:f>
              <c:numCache>
                <c:formatCode>General</c:formatCode>
                <c:ptCount val="2"/>
                <c:pt idx="0">
                  <c:v>1</c:v>
                </c:pt>
                <c:pt idx="1">
                  <c:v>0.908345821577103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362304"/>
        <c:axId val="92103040"/>
      </c:barChart>
      <c:catAx>
        <c:axId val="753623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2103040"/>
        <c:crosses val="autoZero"/>
        <c:auto val="1"/>
        <c:lblAlgn val="ctr"/>
        <c:lblOffset val="100"/>
        <c:noMultiLvlLbl val="0"/>
      </c:catAx>
      <c:valAx>
        <c:axId val="92103040"/>
        <c:scaling>
          <c:orientation val="minMax"/>
          <c:max val="1.5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536230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0224(ＰＦＫＭ，ＰＧＤ，ＴＡＬＤＯ）'!$R$2:$R$3</c:f>
                <c:numCache>
                  <c:formatCode>General</c:formatCode>
                  <c:ptCount val="2"/>
                  <c:pt idx="0">
                    <c:v>4.0416066850203318E-2</c:v>
                  </c:pt>
                  <c:pt idx="1">
                    <c:v>2.228222438993922E-2</c:v>
                  </c:pt>
                </c:numCache>
              </c:numRef>
            </c:plus>
            <c:minus>
              <c:numRef>
                <c:f>'0224(ＰＦＫＭ，ＰＧＤ，ＴＡＬＤＯ）'!$R$2:$R$3</c:f>
                <c:numCache>
                  <c:formatCode>General</c:formatCode>
                  <c:ptCount val="2"/>
                  <c:pt idx="0">
                    <c:v>4.0416066850203318E-2</c:v>
                  </c:pt>
                  <c:pt idx="1">
                    <c:v>2.228222438993922E-2</c:v>
                  </c:pt>
                </c:numCache>
              </c:numRef>
            </c:minus>
          </c:errBars>
          <c:cat>
            <c:strRef>
              <c:f>'0224(ＰＦＫＭ，ＰＧＤ，ＴＡＬＤＯ）'!$J$2:$J$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'0224(ＰＦＫＭ，ＰＧＤ，ＴＡＬＤＯ）'!$Q$2:$Q$3</c:f>
              <c:numCache>
                <c:formatCode>General</c:formatCode>
                <c:ptCount val="2"/>
                <c:pt idx="0">
                  <c:v>1</c:v>
                </c:pt>
                <c:pt idx="1">
                  <c:v>0.94668540374179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2137728"/>
        <c:axId val="97917568"/>
      </c:barChart>
      <c:catAx>
        <c:axId val="921377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7917568"/>
        <c:crosses val="autoZero"/>
        <c:auto val="1"/>
        <c:lblAlgn val="ctr"/>
        <c:lblOffset val="100"/>
        <c:noMultiLvlLbl val="0"/>
      </c:catAx>
      <c:valAx>
        <c:axId val="97917568"/>
        <c:scaling>
          <c:orientation val="minMax"/>
          <c:max val="1.1000000000000001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213772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12:$D$13</c:f>
                <c:numCache>
                  <c:formatCode>General</c:formatCode>
                  <c:ptCount val="2"/>
                  <c:pt idx="0">
                    <c:v>0.35867055268035014</c:v>
                  </c:pt>
                  <c:pt idx="1">
                    <c:v>0.19664329373088529</c:v>
                  </c:pt>
                </c:numCache>
              </c:numRef>
            </c:plus>
            <c:minus>
              <c:numRef>
                <c:f>まとめ!$D$12:$D$13</c:f>
                <c:numCache>
                  <c:formatCode>General</c:formatCode>
                  <c:ptCount val="2"/>
                  <c:pt idx="0">
                    <c:v>0.35867055268035014</c:v>
                  </c:pt>
                  <c:pt idx="1">
                    <c:v>0.19664329373088529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12:$C$13</c:f>
              <c:numCache>
                <c:formatCode>General</c:formatCode>
                <c:ptCount val="2"/>
                <c:pt idx="0">
                  <c:v>1</c:v>
                </c:pt>
                <c:pt idx="1">
                  <c:v>0.77113777703686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856704"/>
        <c:axId val="204862592"/>
      </c:barChart>
      <c:catAx>
        <c:axId val="2048567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04862592"/>
        <c:crosses val="autoZero"/>
        <c:auto val="1"/>
        <c:lblAlgn val="ctr"/>
        <c:lblOffset val="100"/>
        <c:noMultiLvlLbl val="0"/>
      </c:catAx>
      <c:valAx>
        <c:axId val="204862592"/>
        <c:scaling>
          <c:orientation val="minMax"/>
          <c:max val="1.6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0485670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14:$D$15</c:f>
                <c:numCache>
                  <c:formatCode>General</c:formatCode>
                  <c:ptCount val="2"/>
                  <c:pt idx="0">
                    <c:v>4.588060004098559E-2</c:v>
                  </c:pt>
                  <c:pt idx="1">
                    <c:v>3.0365108429497811E-2</c:v>
                  </c:pt>
                </c:numCache>
              </c:numRef>
            </c:plus>
            <c:minus>
              <c:numRef>
                <c:f>まとめ!$D$14:$D$15</c:f>
                <c:numCache>
                  <c:formatCode>General</c:formatCode>
                  <c:ptCount val="2"/>
                  <c:pt idx="0">
                    <c:v>4.588060004098559E-2</c:v>
                  </c:pt>
                  <c:pt idx="1">
                    <c:v>3.0365108429497811E-2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14:$C$15</c:f>
              <c:numCache>
                <c:formatCode>General</c:formatCode>
                <c:ptCount val="2"/>
                <c:pt idx="0">
                  <c:v>1</c:v>
                </c:pt>
                <c:pt idx="1">
                  <c:v>0.85003087219328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857920"/>
        <c:axId val="75239808"/>
      </c:barChart>
      <c:catAx>
        <c:axId val="20785792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5239808"/>
        <c:crosses val="autoZero"/>
        <c:auto val="1"/>
        <c:lblAlgn val="ctr"/>
        <c:lblOffset val="100"/>
        <c:noMultiLvlLbl val="0"/>
      </c:catAx>
      <c:valAx>
        <c:axId val="75239808"/>
        <c:scaling>
          <c:orientation val="minMax"/>
          <c:max val="1.1000000000000001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0785792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16:$D$17</c:f>
                <c:numCache>
                  <c:formatCode>General</c:formatCode>
                  <c:ptCount val="2"/>
                  <c:pt idx="0">
                    <c:v>8.2208416353233768E-2</c:v>
                  </c:pt>
                  <c:pt idx="1">
                    <c:v>9.8707027124577185E-2</c:v>
                  </c:pt>
                </c:numCache>
              </c:numRef>
            </c:plus>
            <c:minus>
              <c:numRef>
                <c:f>まとめ!$D$16:$D$17</c:f>
                <c:numCache>
                  <c:formatCode>General</c:formatCode>
                  <c:ptCount val="2"/>
                  <c:pt idx="0">
                    <c:v>8.2208416353233768E-2</c:v>
                  </c:pt>
                  <c:pt idx="1">
                    <c:v>9.8707027124577185E-2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16:$C$17</c:f>
              <c:numCache>
                <c:formatCode>General</c:formatCode>
                <c:ptCount val="2"/>
                <c:pt idx="0">
                  <c:v>1</c:v>
                </c:pt>
                <c:pt idx="1">
                  <c:v>0.848020740131969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248384"/>
        <c:axId val="75249920"/>
      </c:barChart>
      <c:catAx>
        <c:axId val="752483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5249920"/>
        <c:crosses val="autoZero"/>
        <c:auto val="1"/>
        <c:lblAlgn val="ctr"/>
        <c:lblOffset val="100"/>
        <c:noMultiLvlLbl val="0"/>
      </c:catAx>
      <c:valAx>
        <c:axId val="75249920"/>
        <c:scaling>
          <c:orientation val="minMax"/>
          <c:max val="1.1000000000000001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524838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18:$D$19</c:f>
                <c:numCache>
                  <c:formatCode>General</c:formatCode>
                  <c:ptCount val="2"/>
                  <c:pt idx="0">
                    <c:v>0.23806471865329182</c:v>
                  </c:pt>
                  <c:pt idx="1">
                    <c:v>6.4583431887615006E-2</c:v>
                  </c:pt>
                </c:numCache>
              </c:numRef>
            </c:plus>
            <c:minus>
              <c:numRef>
                <c:f>まとめ!$D$18:$D$19</c:f>
                <c:numCache>
                  <c:formatCode>General</c:formatCode>
                  <c:ptCount val="2"/>
                  <c:pt idx="0">
                    <c:v>0.23806471865329182</c:v>
                  </c:pt>
                  <c:pt idx="1">
                    <c:v>6.4583431887615006E-2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18:$C$19</c:f>
              <c:numCache>
                <c:formatCode>General</c:formatCode>
                <c:ptCount val="2"/>
                <c:pt idx="0">
                  <c:v>1</c:v>
                </c:pt>
                <c:pt idx="1">
                  <c:v>0.804969182179919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7699712"/>
        <c:axId val="77713792"/>
      </c:barChart>
      <c:catAx>
        <c:axId val="7769971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7713792"/>
        <c:crosses val="autoZero"/>
        <c:auto val="1"/>
        <c:lblAlgn val="ctr"/>
        <c:lblOffset val="100"/>
        <c:noMultiLvlLbl val="0"/>
      </c:catAx>
      <c:valAx>
        <c:axId val="77713792"/>
        <c:scaling>
          <c:orientation val="minMax"/>
          <c:max val="1.3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7699712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42:$D$43</c:f>
                <c:numCache>
                  <c:formatCode>General</c:formatCode>
                  <c:ptCount val="2"/>
                  <c:pt idx="0">
                    <c:v>0.21534302196912927</c:v>
                  </c:pt>
                  <c:pt idx="1">
                    <c:v>0.14185602358198754</c:v>
                  </c:pt>
                </c:numCache>
              </c:numRef>
            </c:plus>
            <c:minus>
              <c:numRef>
                <c:f>まとめ!$D$42:$D$43</c:f>
                <c:numCache>
                  <c:formatCode>General</c:formatCode>
                  <c:ptCount val="2"/>
                  <c:pt idx="0">
                    <c:v>0.21534302196912927</c:v>
                  </c:pt>
                  <c:pt idx="1">
                    <c:v>0.14185602358198754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42:$C$43</c:f>
              <c:numCache>
                <c:formatCode>General</c:formatCode>
                <c:ptCount val="2"/>
                <c:pt idx="0">
                  <c:v>1</c:v>
                </c:pt>
                <c:pt idx="1">
                  <c:v>0.828813297447533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44384"/>
        <c:axId val="79345920"/>
      </c:barChart>
      <c:catAx>
        <c:axId val="793443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9345920"/>
        <c:crosses val="autoZero"/>
        <c:auto val="1"/>
        <c:lblAlgn val="ctr"/>
        <c:lblOffset val="100"/>
        <c:noMultiLvlLbl val="0"/>
      </c:catAx>
      <c:valAx>
        <c:axId val="79345920"/>
        <c:scaling>
          <c:orientation val="minMax"/>
          <c:max val="1.3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934438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15181435653876"/>
          <c:y val="0.13262777777777779"/>
          <c:w val="0.64333402777777771"/>
          <c:h val="0.69052777777777774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まとめ!$D$44:$D$45</c:f>
                <c:numCache>
                  <c:formatCode>General</c:formatCode>
                  <c:ptCount val="2"/>
                  <c:pt idx="0">
                    <c:v>0.3166667310857097</c:v>
                  </c:pt>
                  <c:pt idx="1">
                    <c:v>0.17893326885326696</c:v>
                  </c:pt>
                </c:numCache>
              </c:numRef>
            </c:plus>
            <c:minus>
              <c:numRef>
                <c:f>まとめ!$D$44:$D$45</c:f>
                <c:numCache>
                  <c:formatCode>General</c:formatCode>
                  <c:ptCount val="2"/>
                  <c:pt idx="0">
                    <c:v>0.3166667310857097</c:v>
                  </c:pt>
                  <c:pt idx="1">
                    <c:v>0.17893326885326696</c:v>
                  </c:pt>
                </c:numCache>
              </c:numRef>
            </c:minus>
          </c:errBars>
          <c:cat>
            <c:strRef>
              <c:f>まとめ!$B$12:$B$13</c:f>
              <c:strCache>
                <c:ptCount val="2"/>
                <c:pt idx="0">
                  <c:v>Control</c:v>
                </c:pt>
                <c:pt idx="1">
                  <c:v>EVE</c:v>
                </c:pt>
              </c:strCache>
            </c:strRef>
          </c:cat>
          <c:val>
            <c:numRef>
              <c:f>まとめ!$C$44:$C$45</c:f>
              <c:numCache>
                <c:formatCode>General</c:formatCode>
                <c:ptCount val="2"/>
                <c:pt idx="0">
                  <c:v>1</c:v>
                </c:pt>
                <c:pt idx="1">
                  <c:v>0.852802088319271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9395456"/>
        <c:axId val="79417728"/>
      </c:barChart>
      <c:catAx>
        <c:axId val="7939545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9417728"/>
        <c:crosses val="autoZero"/>
        <c:auto val="1"/>
        <c:lblAlgn val="ctr"/>
        <c:lblOffset val="100"/>
        <c:noMultiLvlLbl val="0"/>
      </c:catAx>
      <c:valAx>
        <c:axId val="79417728"/>
        <c:scaling>
          <c:orientation val="minMax"/>
          <c:max val="1.5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7939545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43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379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233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911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172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2869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770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03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540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932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67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A8ACF-7A08-4A77-B078-9749D9F80A6F}" type="datetimeFigureOut">
              <a:rPr kumimoji="1" lang="ja-JP" altLang="en-US" smtClean="0"/>
              <a:t>2017/2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71E42-F113-4087-9763-7EC306890F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527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chart" Target="../charts/chart2.xml"/><Relationship Id="rId26" Type="http://schemas.microsoft.com/office/2007/relationships/hdphoto" Target="../media/hdphoto8.wdp"/><Relationship Id="rId3" Type="http://schemas.microsoft.com/office/2007/relationships/hdphoto" Target="../media/hdphoto1.wdp"/><Relationship Id="rId21" Type="http://schemas.openxmlformats.org/officeDocument/2006/relationships/chart" Target="../charts/chart5.xml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chart" Target="../charts/chart1.xml"/><Relationship Id="rId25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chart" Target="../charts/chart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chart" Target="../charts/chart8.xml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chart" Target="../charts/chart7.xml"/><Relationship Id="rId10" Type="http://schemas.openxmlformats.org/officeDocument/2006/relationships/image" Target="../media/image5.png"/><Relationship Id="rId19" Type="http://schemas.openxmlformats.org/officeDocument/2006/relationships/chart" Target="../charts/chart3.xml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497615" y="238174"/>
            <a:ext cx="8056009" cy="6429437"/>
            <a:chOff x="497615" y="238174"/>
            <a:chExt cx="8056009" cy="6429437"/>
          </a:xfrm>
        </p:grpSpPr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0" y="643916"/>
              <a:ext cx="1611962" cy="54317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0" y="3926051"/>
              <a:ext cx="1620000" cy="57988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497615" y="6147919"/>
              <a:ext cx="9589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695586" y="4031328"/>
              <a:ext cx="7296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646760" y="730838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T1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763714" y="1343807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1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74559" y="2676504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1/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677954" y="3370571"/>
              <a:ext cx="7425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77933" y="5441103"/>
              <a:ext cx="9660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LDO1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Picture 8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2" y="2537170"/>
              <a:ext cx="1620000" cy="64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1" y="3234515"/>
              <a:ext cx="1620000" cy="6424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4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1" y="1229325"/>
              <a:ext cx="1620000" cy="59829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4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0" y="5997559"/>
              <a:ext cx="1620000" cy="67005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8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16592" y="4553832"/>
              <a:ext cx="1620000" cy="715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" name="テキスト ボックス 34"/>
            <p:cNvSpPr txBox="1"/>
            <p:nvPr/>
          </p:nvSpPr>
          <p:spPr>
            <a:xfrm>
              <a:off x="791699" y="4726772"/>
              <a:ext cx="6286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D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2025747" y="238174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2862557" y="238174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VE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Picture 6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8552" y="5308480"/>
              <a:ext cx="1620000" cy="64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aphicFrame>
          <p:nvGraphicFramePr>
            <p:cNvPr id="22" name="グラフ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01317859"/>
                </p:ext>
              </p:extLst>
            </p:nvPr>
          </p:nvGraphicFramePr>
          <p:xfrm>
            <a:off x="4163560" y="5155018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aphicFrame>
          <p:nvGraphicFramePr>
            <p:cNvPr id="23" name="グラフ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27253813"/>
                </p:ext>
              </p:extLst>
            </p:nvPr>
          </p:nvGraphicFramePr>
          <p:xfrm>
            <a:off x="7041616" y="1713994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aphicFrame>
          <p:nvGraphicFramePr>
            <p:cNvPr id="24" name="グラフ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34869509"/>
                </p:ext>
              </p:extLst>
            </p:nvPr>
          </p:nvGraphicFramePr>
          <p:xfrm>
            <a:off x="5610177" y="1739366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graphicFrame>
          <p:nvGraphicFramePr>
            <p:cNvPr id="25" name="グラフ 2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7424174"/>
                </p:ext>
              </p:extLst>
            </p:nvPr>
          </p:nvGraphicFramePr>
          <p:xfrm>
            <a:off x="4156529" y="3523290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27" name="グラフ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61896514"/>
                </p:ext>
              </p:extLst>
            </p:nvPr>
          </p:nvGraphicFramePr>
          <p:xfrm>
            <a:off x="5606415" y="3522016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28" name="グラフ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74374609"/>
                </p:ext>
              </p:extLst>
            </p:nvPr>
          </p:nvGraphicFramePr>
          <p:xfrm>
            <a:off x="5610177" y="5164890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graphicFrame>
          <p:nvGraphicFramePr>
            <p:cNvPr id="29" name="グラフ 2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7169104"/>
                </p:ext>
              </p:extLst>
            </p:nvPr>
          </p:nvGraphicFramePr>
          <p:xfrm>
            <a:off x="4162164" y="1749328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graphicFrame>
          <p:nvGraphicFramePr>
            <p:cNvPr id="30" name="グラフ 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96827067"/>
                </p:ext>
              </p:extLst>
            </p:nvPr>
          </p:nvGraphicFramePr>
          <p:xfrm>
            <a:off x="7113624" y="3469697"/>
            <a:ext cx="144000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sp>
          <p:nvSpPr>
            <p:cNvPr id="31" name="テキスト ボックス 30"/>
            <p:cNvSpPr txBox="1"/>
            <p:nvPr/>
          </p:nvSpPr>
          <p:spPr>
            <a:xfrm>
              <a:off x="7550515" y="3347234"/>
              <a:ext cx="663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4670456" y="1603999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T1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6195834" y="1575591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K1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660585" y="3351978"/>
              <a:ext cx="822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1/2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6139869" y="3346685"/>
              <a:ext cx="6735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KM2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6042225" y="5051938"/>
              <a:ext cx="8686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LDO1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4727624" y="5069362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D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7556893" y="1581792"/>
              <a:ext cx="683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KM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Picture 7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916594" y="1864511"/>
              <a:ext cx="1619998" cy="64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4" name="テキスト ボックス 43"/>
            <p:cNvSpPr txBox="1"/>
            <p:nvPr/>
          </p:nvSpPr>
          <p:spPr>
            <a:xfrm>
              <a:off x="666731" y="2000245"/>
              <a:ext cx="7537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KM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5112859" y="3665482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08433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1</Words>
  <Application>Microsoft Office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vise実験結果</dc:title>
  <dc:creator>FJ-USER</dc:creator>
  <cp:lastModifiedBy>FJ-USER</cp:lastModifiedBy>
  <cp:revision>15</cp:revision>
  <dcterms:created xsi:type="dcterms:W3CDTF">2017-02-22T07:40:48Z</dcterms:created>
  <dcterms:modified xsi:type="dcterms:W3CDTF">2017-02-28T02:03:46Z</dcterms:modified>
</cp:coreProperties>
</file>